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533520" y="764280"/>
            <a:ext cx="6704640" cy="37713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77240" y="4777560"/>
            <a:ext cx="6217560" cy="452592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372840" cy="50256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399200" y="0"/>
            <a:ext cx="3372840" cy="50256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9555480"/>
            <a:ext cx="3372840" cy="50256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399200" y="9555480"/>
            <a:ext cx="3372840" cy="502560"/>
          </a:xfrm>
          <a:prstGeom prst="rect">
            <a:avLst/>
          </a:prstGeom>
        </p:spPr>
        <p:txBody>
          <a:bodyPr lIns="0" rIns="0" tIns="0" bIns="0" anchor="b"/>
          <a:p>
            <a:pPr algn="r"/>
            <a:fld id="{5293CD21-B64E-4C7F-AABA-591DE403734F}"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endParaRPr b="0" lang="en-US" sz="2000" spc="-1" strike="noStrike">
              <a:latin typeface="Arial"/>
            </a:endParaRPr>
          </a:p>
          <a:p>
            <a:endParaRPr b="0" lang="en-US" sz="20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2147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Intragraft B cell differentiation during the development of tolerance to kidney allografts is associated with a regulatory B cell signature revealed by single cell transcriptomics</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Michael Tyler Guinn, Edward S. Szuter, Takahiro Yokose, Jifu Ge, Ivy A. Rosales, Kashish Chetal, Ruslan I. Sadreyev, Alex G. Cuenca, Daniel Kreisel, Peter T. Sage, Paul S. Russell, Joren C. Madsen, Robert B. Colvin, Alessandro Alessandrini</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American Journal of Transplantation</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23 Issue 9 Pages 1319-1330 (Septem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ajt.2023.05.036</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4238640" y="79200"/>
            <a:ext cx="66672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Figs2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1422360" y="2115360"/>
            <a:ext cx="6350040" cy="227808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American Journal of Transplantation</a:t>
            </a:r>
            <a:r>
              <a:rPr b="0" lang="en-US" sz="900" spc="-1" strike="noStrike">
                <a:solidFill>
                  <a:srgbClr val="ffffff"/>
                </a:solidFill>
                <a:latin typeface="Arial"/>
              </a:rPr>
              <a:t> 2023 231319-1330DOI: (10.1016/j.ajt.2023.05.036)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